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jpeg" ContentType="image/jpeg"/>
  <Override PartName="/ppt/media/image7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5128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7280" y="744120"/>
            <a:ext cx="4962600" cy="37227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906480" y="4714560"/>
            <a:ext cx="498456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굴림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5128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5F91C56-686C-4B07-8568-430EC924ABCD}" type="slidenum">
              <a:rPr b="0" lang="en-US" sz="12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Rectangle 7"/>
          <p:cNvSpPr/>
          <p:nvPr/>
        </p:nvSpPr>
        <p:spPr>
          <a:xfrm>
            <a:off x="385128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2917FF7-5E3B-4155-8DB1-426A2A14F3B0}" type="slidenum">
              <a:rPr b="0" lang="en-US" sz="12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9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100" name="PlaceHolder 2"/>
          <p:cNvSpPr>
            <a:spLocks noGrp="1"/>
          </p:cNvSpPr>
          <p:nvPr>
            <p:ph type="body"/>
          </p:nvPr>
        </p:nvSpPr>
        <p:spPr>
          <a:xfrm>
            <a:off x="906480" y="4714560"/>
            <a:ext cx="498456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Rectangle 7"/>
          <p:cNvSpPr/>
          <p:nvPr/>
        </p:nvSpPr>
        <p:spPr>
          <a:xfrm>
            <a:off x="385128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C88A386-314C-4EAA-8BC4-335BC2352CB8}" type="slidenum">
              <a:rPr b="0" lang="en-US" sz="12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2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103" name="PlaceHolder 2"/>
          <p:cNvSpPr>
            <a:spLocks noGrp="1"/>
          </p:cNvSpPr>
          <p:nvPr>
            <p:ph type="body"/>
          </p:nvPr>
        </p:nvSpPr>
        <p:spPr>
          <a:xfrm>
            <a:off x="906480" y="4714560"/>
            <a:ext cx="4984560" cy="446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굴림"/>
              </a:rPr>
              <a:t>                                                            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3E870E-3747-414C-8D0F-13FA68CDAB6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60EA03-E0E5-4C85-B230-CF92F84E1B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37C819-18D6-4335-960B-B11ABE38836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4584F4-627F-4F00-A49B-99E3C8CC5C9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839D49-1263-4ECC-91DB-C66F7A04142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999CEB-327D-41EE-90C0-F6E6941874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069D75-B30B-4020-BE99-D9DD955566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F2BE89-98CD-4F84-8B96-89135620F8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B0C897-C948-4A2A-BC32-12F1835DC4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916DCA-87FA-48A6-A0C9-E6D2C7CD4B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2CDE84-42E4-4D00-9C49-C24C42EB67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2D514C-7E9F-42FF-9A5F-6655BFF8BD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AE6836E-59B5-4792-9CB8-28F9267C64D9}" type="slidenum">
              <a:rPr b="0" lang="en-US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5" Type="http://schemas.openxmlformats.org/officeDocument/2006/relationships/image" Target="../media/image6.jpeg"/><Relationship Id="rId6" Type="http://schemas.openxmlformats.org/officeDocument/2006/relationships/image" Target="../media/image7.jpe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14"/>
          <p:cNvSpPr/>
          <p:nvPr/>
        </p:nvSpPr>
        <p:spPr>
          <a:xfrm>
            <a:off x="0" y="115920"/>
            <a:ext cx="642924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굴림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굴림"/>
              </a:rPr>
              <a:t>Supplementary Fig.S1. PTX-induced apoptosis in parental SKOV3 cells and PTX-resistant SKpac cells. </a:t>
            </a:r>
            <a:r>
              <a:rPr b="0" lang="en-US" sz="1400" spc="-1" strike="noStrike">
                <a:solidFill>
                  <a:srgbClr val="000000"/>
                </a:solidFill>
                <a:latin typeface="굴림"/>
              </a:rPr>
              <a:t>Apoptotic rate was evaluated by TUNEL assay in SKOV3 and SKpac cells after treatment with 80 nM PTX for 48h. SKOV3 cells showed a high apoptotic rate (98.24%), whereas PTX-resistant SKpac cells showed a marked reduction of apoptosis (1.1%)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9" name="Text Box 15"/>
          <p:cNvSpPr/>
          <p:nvPr/>
        </p:nvSpPr>
        <p:spPr>
          <a:xfrm>
            <a:off x="108000" y="476280"/>
            <a:ext cx="507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굴림"/>
              </a:rPr>
              <a:t>.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grpSp>
        <p:nvGrpSpPr>
          <p:cNvPr id="50" name="Group 36"/>
          <p:cNvGrpSpPr/>
          <p:nvPr/>
        </p:nvGrpSpPr>
        <p:grpSpPr>
          <a:xfrm>
            <a:off x="7000920" y="857160"/>
            <a:ext cx="1300680" cy="331920"/>
            <a:chOff x="7000920" y="857160"/>
            <a:chExt cx="1300680" cy="331920"/>
          </a:xfrm>
        </p:grpSpPr>
        <p:sp>
          <p:nvSpPr>
            <p:cNvPr id="51" name="Text Box 37"/>
            <p:cNvSpPr/>
            <p:nvPr/>
          </p:nvSpPr>
          <p:spPr>
            <a:xfrm>
              <a:off x="7300800" y="957960"/>
              <a:ext cx="991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PTX 80nM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grpSp>
          <p:nvGrpSpPr>
            <p:cNvPr id="52" name="Group 38"/>
            <p:cNvGrpSpPr/>
            <p:nvPr/>
          </p:nvGrpSpPr>
          <p:grpSpPr>
            <a:xfrm>
              <a:off x="7000920" y="857160"/>
              <a:ext cx="1300680" cy="231120"/>
              <a:chOff x="7000920" y="857160"/>
              <a:chExt cx="1300680" cy="231120"/>
            </a:xfrm>
          </p:grpSpPr>
          <p:sp>
            <p:nvSpPr>
              <p:cNvPr id="53" name="Line 39"/>
              <p:cNvSpPr/>
              <p:nvPr/>
            </p:nvSpPr>
            <p:spPr>
              <a:xfrm flipV="1">
                <a:off x="7000920" y="1004400"/>
                <a:ext cx="299520" cy="180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4" name="Text Box 40"/>
              <p:cNvSpPr/>
              <p:nvPr/>
            </p:nvSpPr>
            <p:spPr>
              <a:xfrm>
                <a:off x="7300440" y="857160"/>
                <a:ext cx="10011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56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PTX  0nM</a:t>
                </a:r>
                <a:endParaRPr b="0" lang="en-US" sz="9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5" name="Line 41"/>
              <p:cNvSpPr/>
              <p:nvPr/>
            </p:nvSpPr>
            <p:spPr>
              <a:xfrm>
                <a:off x="7000920" y="956880"/>
                <a:ext cx="2995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</p:grpSp>
      <p:grpSp>
        <p:nvGrpSpPr>
          <p:cNvPr id="56" name="Group 34"/>
          <p:cNvGrpSpPr/>
          <p:nvPr/>
        </p:nvGrpSpPr>
        <p:grpSpPr>
          <a:xfrm>
            <a:off x="2286000" y="2286000"/>
            <a:ext cx="5334120" cy="3600360"/>
            <a:chOff x="2286000" y="2286000"/>
            <a:chExt cx="5334120" cy="3600360"/>
          </a:xfrm>
        </p:grpSpPr>
        <p:pic>
          <p:nvPicPr>
            <p:cNvPr id="57" name="Picture 26" descr=""/>
            <p:cNvPicPr/>
            <p:nvPr/>
          </p:nvPicPr>
          <p:blipFill>
            <a:blip r:embed="rId1"/>
            <a:srcRect l="9817" t="54236" r="5881" b="1924"/>
            <a:stretch/>
          </p:blipFill>
          <p:spPr>
            <a:xfrm>
              <a:off x="2514600" y="4079880"/>
              <a:ext cx="5023080" cy="1806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" name="Text Box 27"/>
            <p:cNvSpPr/>
            <p:nvPr/>
          </p:nvSpPr>
          <p:spPr>
            <a:xfrm>
              <a:off x="6553440" y="4203720"/>
              <a:ext cx="487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SKpac</a:t>
              </a:r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pic>
          <p:nvPicPr>
            <p:cNvPr id="59" name="Picture 35" descr=""/>
            <p:cNvPicPr/>
            <p:nvPr/>
          </p:nvPicPr>
          <p:blipFill>
            <a:blip r:embed="rId2"/>
            <a:srcRect l="8093" t="2306" r="5881" b="52693"/>
            <a:stretch/>
          </p:blipFill>
          <p:spPr>
            <a:xfrm>
              <a:off x="2552760" y="2286000"/>
              <a:ext cx="5067360" cy="1806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0" name="Text Box 42"/>
            <p:cNvSpPr/>
            <p:nvPr/>
          </p:nvSpPr>
          <p:spPr>
            <a:xfrm>
              <a:off x="6477120" y="2438280"/>
              <a:ext cx="584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SKOV3</a:t>
              </a:r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61" name="Text Box 32"/>
            <p:cNvSpPr/>
            <p:nvPr/>
          </p:nvSpPr>
          <p:spPr>
            <a:xfrm rot="16200000">
              <a:off x="2104200" y="2924280"/>
              <a:ext cx="609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ounts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62" name="Text Box 33"/>
            <p:cNvSpPr/>
            <p:nvPr/>
          </p:nvSpPr>
          <p:spPr>
            <a:xfrm rot="16200000">
              <a:off x="2104200" y="4753080"/>
              <a:ext cx="609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ounts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sp>
        <p:nvSpPr>
          <p:cNvPr id="63" name="Text Box 99"/>
          <p:cNvSpPr/>
          <p:nvPr/>
        </p:nvSpPr>
        <p:spPr>
          <a:xfrm>
            <a:off x="1214280" y="2214720"/>
            <a:ext cx="584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굴림"/>
              </a:rPr>
              <a:t>A.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Text Box 2"/>
          <p:cNvSpPr/>
          <p:nvPr/>
        </p:nvSpPr>
        <p:spPr>
          <a:xfrm>
            <a:off x="0" y="428760"/>
            <a:ext cx="7358040" cy="137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굴림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굴림"/>
              </a:rPr>
              <a:t>Supplementary Fig.S2. The efficiency of PI3Kp110β siRNA transfection on PTX-resistant SKpac cells</a:t>
            </a:r>
            <a:r>
              <a:rPr b="0" lang="en-US" sz="1400" spc="-1" strike="noStrike">
                <a:solidFill>
                  <a:srgbClr val="000000"/>
                </a:solidFill>
                <a:latin typeface="굴림"/>
              </a:rPr>
              <a:t>. 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굴림"/>
              </a:rPr>
              <a:t>(A and B) SKpac cells were transfected with negative siRNA or PI3K p110 β siRNA. RT-PCR (A) and Western blot analysis (B) demonstrated significant reduction of PI3Kp110β mRNA (98% at 24 h, 36.5% at 48 h, and 51.8% at 72 h) and protein (90% at 48 h) after treatment of PI3Kp110 β siRNA. 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5" name="Text Box 51"/>
          <p:cNvSpPr/>
          <p:nvPr/>
        </p:nvSpPr>
        <p:spPr>
          <a:xfrm>
            <a:off x="4643280" y="2143080"/>
            <a:ext cx="609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굴림"/>
              </a:rPr>
              <a:t>B.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6" name="Text Box 99"/>
          <p:cNvSpPr/>
          <p:nvPr/>
        </p:nvSpPr>
        <p:spPr>
          <a:xfrm>
            <a:off x="214200" y="2000160"/>
            <a:ext cx="584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굴림"/>
              </a:rPr>
              <a:t>A.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grpSp>
        <p:nvGrpSpPr>
          <p:cNvPr id="67" name="그룹 35"/>
          <p:cNvGrpSpPr/>
          <p:nvPr/>
        </p:nvGrpSpPr>
        <p:grpSpPr>
          <a:xfrm>
            <a:off x="214200" y="2000160"/>
            <a:ext cx="4286520" cy="3211920"/>
            <a:chOff x="214200" y="2000160"/>
            <a:chExt cx="4286520" cy="3211920"/>
          </a:xfrm>
        </p:grpSpPr>
        <p:pic>
          <p:nvPicPr>
            <p:cNvPr id="68" name="차트 36" descr=""/>
            <p:cNvPicPr/>
            <p:nvPr/>
          </p:nvPicPr>
          <p:blipFill>
            <a:blip r:embed="rId1"/>
            <a:stretch/>
          </p:blipFill>
          <p:spPr>
            <a:xfrm>
              <a:off x="633240" y="2000160"/>
              <a:ext cx="3867480" cy="22143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69" name="그룹 31"/>
            <p:cNvGrpSpPr/>
            <p:nvPr/>
          </p:nvGrpSpPr>
          <p:grpSpPr>
            <a:xfrm>
              <a:off x="214200" y="4144320"/>
              <a:ext cx="3944520" cy="1067760"/>
              <a:chOff x="214200" y="4144320"/>
              <a:chExt cx="3944520" cy="1067760"/>
            </a:xfrm>
          </p:grpSpPr>
          <p:sp>
            <p:nvSpPr>
              <p:cNvPr id="70" name="Text Box 59"/>
              <p:cNvSpPr/>
              <p:nvPr/>
            </p:nvSpPr>
            <p:spPr>
              <a:xfrm>
                <a:off x="214200" y="4672440"/>
                <a:ext cx="1260720" cy="539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굴림"/>
                  </a:rPr>
                  <a:t>   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굴림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Negative siRNA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        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p110 ß siRNA 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71" name="Text Box 74"/>
              <p:cNvSpPr/>
              <p:nvPr/>
            </p:nvSpPr>
            <p:spPr>
              <a:xfrm>
                <a:off x="507600" y="4212720"/>
                <a:ext cx="10576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      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p110ß </a:t>
                </a:r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72" name="Text Box 75"/>
              <p:cNvSpPr/>
              <p:nvPr/>
            </p:nvSpPr>
            <p:spPr>
              <a:xfrm>
                <a:off x="693000" y="4469760"/>
                <a:ext cx="7390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GAPDH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pic>
            <p:nvPicPr>
              <p:cNvPr id="73" name="Object 76" descr=""/>
              <p:cNvPicPr/>
              <p:nvPr/>
            </p:nvPicPr>
            <p:blipFill>
              <a:blip r:embed="rId2"/>
              <a:stretch/>
            </p:blipFill>
            <p:spPr>
              <a:xfrm>
                <a:off x="1294200" y="4448160"/>
                <a:ext cx="2855160" cy="2869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4" name="Text Box 58"/>
              <p:cNvSpPr/>
              <p:nvPr/>
            </p:nvSpPr>
            <p:spPr>
              <a:xfrm>
                <a:off x="1468800" y="4665960"/>
                <a:ext cx="290160" cy="362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굴림"/>
                  </a:rPr>
                  <a:t>+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굴림"/>
                  </a:rPr>
                  <a:t>-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75" name="Text Box 60"/>
              <p:cNvSpPr/>
              <p:nvPr/>
            </p:nvSpPr>
            <p:spPr>
              <a:xfrm>
                <a:off x="2352240" y="4662720"/>
                <a:ext cx="387000" cy="362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굴림"/>
                  </a:rPr>
                  <a:t>+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굴림"/>
                  </a:rPr>
                  <a:t>-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76" name="Text Box 61"/>
              <p:cNvSpPr/>
              <p:nvPr/>
            </p:nvSpPr>
            <p:spPr>
              <a:xfrm>
                <a:off x="1893960" y="4662720"/>
                <a:ext cx="387000" cy="362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굴림"/>
                  </a:rPr>
                  <a:t>-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굴림"/>
                  </a:rPr>
                  <a:t>+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77" name="Text Box 62"/>
              <p:cNvSpPr/>
              <p:nvPr/>
            </p:nvSpPr>
            <p:spPr>
              <a:xfrm>
                <a:off x="2801160" y="4662720"/>
                <a:ext cx="388440" cy="362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굴림"/>
                  </a:rPr>
                  <a:t>-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굴림"/>
                  </a:rPr>
                  <a:t>+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78" name="Text Box 63"/>
              <p:cNvSpPr/>
              <p:nvPr/>
            </p:nvSpPr>
            <p:spPr>
              <a:xfrm>
                <a:off x="3273840" y="4662720"/>
                <a:ext cx="291600" cy="362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굴림"/>
                  </a:rPr>
                  <a:t>+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굴림"/>
                  </a:rPr>
                  <a:t>-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79" name="Text Box 64"/>
              <p:cNvSpPr/>
              <p:nvPr/>
            </p:nvSpPr>
            <p:spPr>
              <a:xfrm>
                <a:off x="3720960" y="4662720"/>
                <a:ext cx="388440" cy="362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굴림"/>
                  </a:rPr>
                  <a:t>-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굴림"/>
                  </a:rPr>
                  <a:t>+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pic>
            <p:nvPicPr>
              <p:cNvPr id="80" name="Picture 9" descr=""/>
              <p:cNvPicPr/>
              <p:nvPr/>
            </p:nvPicPr>
            <p:blipFill>
              <a:blip r:embed="rId3"/>
              <a:stretch/>
            </p:blipFill>
            <p:spPr>
              <a:xfrm>
                <a:off x="1289520" y="4144320"/>
                <a:ext cx="2869200" cy="282240"/>
              </a:xfrm>
              <a:prstGeom prst="rect">
                <a:avLst/>
              </a:prstGeom>
              <a:ln w="0">
                <a:noFill/>
              </a:ln>
            </p:spPr>
          </p:pic>
        </p:grpSp>
      </p:grpSp>
      <p:grpSp>
        <p:nvGrpSpPr>
          <p:cNvPr id="81" name="그룹 49"/>
          <p:cNvGrpSpPr/>
          <p:nvPr/>
        </p:nvGrpSpPr>
        <p:grpSpPr>
          <a:xfrm>
            <a:off x="4572000" y="2214720"/>
            <a:ext cx="4572000" cy="2919600"/>
            <a:chOff x="4572000" y="2214720"/>
            <a:chExt cx="4572000" cy="2919600"/>
          </a:xfrm>
        </p:grpSpPr>
        <p:pic>
          <p:nvPicPr>
            <p:cNvPr id="82" name="차트 50" descr=""/>
            <p:cNvPicPr/>
            <p:nvPr/>
          </p:nvPicPr>
          <p:blipFill>
            <a:blip r:embed="rId4"/>
            <a:stretch/>
          </p:blipFill>
          <p:spPr>
            <a:xfrm>
              <a:off x="4924800" y="2214720"/>
              <a:ext cx="4219200" cy="21643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83" name="그룹 57"/>
            <p:cNvGrpSpPr/>
            <p:nvPr/>
          </p:nvGrpSpPr>
          <p:grpSpPr>
            <a:xfrm>
              <a:off x="4572000" y="4259160"/>
              <a:ext cx="4093560" cy="875160"/>
              <a:chOff x="4572000" y="4259160"/>
              <a:chExt cx="4093560" cy="875160"/>
            </a:xfrm>
          </p:grpSpPr>
          <p:pic>
            <p:nvPicPr>
              <p:cNvPr id="84" name="그림 10" descr="pi3k 최종.jpg"/>
              <p:cNvPicPr/>
              <p:nvPr/>
            </p:nvPicPr>
            <p:blipFill>
              <a:blip r:embed="rId5">
                <a:lum bright="-30000"/>
              </a:blip>
              <a:stretch/>
            </p:blipFill>
            <p:spPr>
              <a:xfrm>
                <a:off x="5670360" y="4259160"/>
                <a:ext cx="2995200" cy="2149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5" name="그림 9" descr="pi3k actin 최종.jpg"/>
              <p:cNvPicPr/>
              <p:nvPr/>
            </p:nvPicPr>
            <p:blipFill>
              <a:blip r:embed="rId6">
                <a:lum bright="-30000"/>
              </a:blip>
              <a:stretch/>
            </p:blipFill>
            <p:spPr>
              <a:xfrm>
                <a:off x="5670360" y="4547160"/>
                <a:ext cx="2995200" cy="2149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6" name="Text Box 82"/>
              <p:cNvSpPr/>
              <p:nvPr/>
            </p:nvSpPr>
            <p:spPr>
              <a:xfrm>
                <a:off x="5054760" y="4556520"/>
                <a:ext cx="671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ß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바탕"/>
                    <a:ea typeface="바탕"/>
                  </a:rPr>
                  <a:t>-acti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굴림"/>
                  </a:rPr>
                  <a:t> </a:t>
                </a:r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87" name="Text Box 83"/>
              <p:cNvSpPr/>
              <p:nvPr/>
            </p:nvSpPr>
            <p:spPr>
              <a:xfrm>
                <a:off x="4884840" y="4268160"/>
                <a:ext cx="9219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just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      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p110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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88" name="Text Box 71"/>
              <p:cNvSpPr/>
              <p:nvPr/>
            </p:nvSpPr>
            <p:spPr>
              <a:xfrm>
                <a:off x="5779080" y="4771800"/>
                <a:ext cx="281520" cy="362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굴림"/>
                  </a:rPr>
                  <a:t>+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굴림"/>
                  </a:rPr>
                  <a:t>-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89" name="Text Box 72"/>
              <p:cNvSpPr/>
              <p:nvPr/>
            </p:nvSpPr>
            <p:spPr>
              <a:xfrm>
                <a:off x="4572000" y="4750560"/>
                <a:ext cx="1248840" cy="377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굴림"/>
                  </a:rPr>
                  <a:t>   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굴림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Negative siRNA  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        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p110 ß siRNA   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0" name="Text Box 73"/>
              <p:cNvSpPr/>
              <p:nvPr/>
            </p:nvSpPr>
            <p:spPr>
              <a:xfrm>
                <a:off x="6788520" y="4750560"/>
                <a:ext cx="372600" cy="362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굴림"/>
                  </a:rPr>
                  <a:t>+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굴림"/>
                  </a:rPr>
                  <a:t>-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1" name="Text Box 74"/>
              <p:cNvSpPr/>
              <p:nvPr/>
            </p:nvSpPr>
            <p:spPr>
              <a:xfrm>
                <a:off x="6267240" y="4750560"/>
                <a:ext cx="372600" cy="362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굴림"/>
                  </a:rPr>
                  <a:t>-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굴림"/>
                  </a:rPr>
                  <a:t>+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2" name="Text Box 75"/>
              <p:cNvSpPr/>
              <p:nvPr/>
            </p:nvSpPr>
            <p:spPr>
              <a:xfrm>
                <a:off x="7304760" y="4750560"/>
                <a:ext cx="374400" cy="362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굴림"/>
                  </a:rPr>
                  <a:t>-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굴림"/>
                  </a:rPr>
                  <a:t>+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3" name="Text Box 76"/>
              <p:cNvSpPr/>
              <p:nvPr/>
            </p:nvSpPr>
            <p:spPr>
              <a:xfrm>
                <a:off x="7771680" y="4750560"/>
                <a:ext cx="279720" cy="362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굴림"/>
                  </a:rPr>
                  <a:t>+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굴림"/>
                  </a:rPr>
                  <a:t>-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4" name="Text Box 77"/>
              <p:cNvSpPr/>
              <p:nvPr/>
            </p:nvSpPr>
            <p:spPr>
              <a:xfrm>
                <a:off x="8278920" y="4750560"/>
                <a:ext cx="374400" cy="362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굴림"/>
                  </a:rPr>
                  <a:t>-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굴림"/>
                  </a:rPr>
                  <a:t>+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</p:grpSp>
      <p:sp>
        <p:nvSpPr>
          <p:cNvPr id="95" name="TextBox 32"/>
          <p:cNvSpPr/>
          <p:nvPr/>
        </p:nvSpPr>
        <p:spPr>
          <a:xfrm>
            <a:off x="3714840" y="1857240"/>
            <a:ext cx="287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굴림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6" name="TextBox 33"/>
          <p:cNvSpPr/>
          <p:nvPr/>
        </p:nvSpPr>
        <p:spPr>
          <a:xfrm>
            <a:off x="6858000" y="2428920"/>
            <a:ext cx="289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굴림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7" name="TextBox 34"/>
          <p:cNvSpPr/>
          <p:nvPr/>
        </p:nvSpPr>
        <p:spPr>
          <a:xfrm>
            <a:off x="7929720" y="2214720"/>
            <a:ext cx="287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굴림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1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0007722</cp:lastModifiedBy>
  <dcterms:modified xsi:type="dcterms:W3CDTF">2013-01-18T02:12:45Z</dcterms:modified>
  <cp:revision>117</cp:revision>
  <dc:subject/>
  <dc:title>PowerPoint 프레젠테이션</dc:title>
</cp:coreProperties>
</file>